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8288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-1143000" y="685440"/>
            <a:ext cx="9144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8C9F91-E81E-49F9-AE53-FC7C2B26831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5A9EEC-622D-43AB-9471-C94E895CBF9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1"/>
          <p:cNvSpPr>
            <a:spLocks noGrp="1"/>
          </p:cNvSpPr>
          <p:nvPr>
            <p:ph type="sldImg"/>
          </p:nvPr>
        </p:nvSpPr>
        <p:spPr>
          <a:xfrm>
            <a:off x="-1143000" y="685800"/>
            <a:ext cx="9144000" cy="3429000"/>
          </a:xfrm>
          <a:prstGeom prst="rect">
            <a:avLst/>
          </a:prstGeom>
          <a:ln w="0">
            <a:noFill/>
          </a:ln>
        </p:spPr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S3. Representative Immunohistochemistry images of formalin-fixed  paraffin-embedded placental villous explants from women with preeclampsia (PE) and normal healthy pregnancy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roteins are localized in the syncytiotrophoblasts (brown stained as pointed out by arrow). Bars represent 100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µm (original magnification X200)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253932-6423-4657-A31E-97CEFE091C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914400" y="1600200"/>
            <a:ext cx="16459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914400" y="3964320"/>
            <a:ext cx="16459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F84A0-60B7-4356-BE8C-619B653CD5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914400" y="160020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9348480" y="160020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914400" y="396432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9348480" y="396432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7CEB3-B715-47CE-9FB0-9EFB625416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914400" y="1600200"/>
            <a:ext cx="52995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6479280" y="1600200"/>
            <a:ext cx="52995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2044160" y="1600200"/>
            <a:ext cx="52995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914400" y="3964320"/>
            <a:ext cx="52995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6479280" y="3964320"/>
            <a:ext cx="52995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2044160" y="3964320"/>
            <a:ext cx="52995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9BD29-CE84-4EAF-BE60-F831515D30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914400" y="1600200"/>
            <a:ext cx="164592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8F5DD-C5F7-4CAD-9F1E-74E0D62D93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914400" y="1600200"/>
            <a:ext cx="164592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69A25-9272-4EB2-A4A3-FAB42F2068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914400" y="1600200"/>
            <a:ext cx="80319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9348480" y="1600200"/>
            <a:ext cx="80319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89A4FE-0BB4-4D71-BF23-5573376FA9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96A42-2B58-41E2-8C81-A7D8D58857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914400" y="274320"/>
            <a:ext cx="164592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4E2D7-8DF2-4214-A283-366BCFC12C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914400" y="160020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9348480" y="1600200"/>
            <a:ext cx="80319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914400" y="396432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C4199-BE6F-4838-9DA0-181AC24DE4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914400" y="1600200"/>
            <a:ext cx="80319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9348480" y="160020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9348480" y="396432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8F4661-D531-498D-99D5-602927BA89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914400" y="160020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9348480" y="1600200"/>
            <a:ext cx="80319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914400" y="3964320"/>
            <a:ext cx="164592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E124DD-208D-42CC-9D23-5F723893FD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914400" y="274320"/>
            <a:ext cx="16459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914400" y="1600200"/>
            <a:ext cx="164592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914040" y="6244920"/>
            <a:ext cx="42670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6248520" y="6244920"/>
            <a:ext cx="57909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3106160" y="6244920"/>
            <a:ext cx="42670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200D55-12D6-4DA2-9A03-91BD7EE1478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53"/>
          <p:cNvGrpSpPr/>
          <p:nvPr/>
        </p:nvGrpSpPr>
        <p:grpSpPr>
          <a:xfrm>
            <a:off x="285840" y="380880"/>
            <a:ext cx="12058200" cy="4876920"/>
            <a:chOff x="285840" y="380880"/>
            <a:chExt cx="12058200" cy="4876920"/>
          </a:xfrm>
        </p:grpSpPr>
        <p:grpSp>
          <p:nvGrpSpPr>
            <p:cNvPr id="49" name="Group 19"/>
            <p:cNvGrpSpPr/>
            <p:nvPr/>
          </p:nvGrpSpPr>
          <p:grpSpPr>
            <a:xfrm>
              <a:off x="285840" y="380880"/>
              <a:ext cx="12058200" cy="4876920"/>
              <a:chOff x="285840" y="380880"/>
              <a:chExt cx="12058200" cy="4876920"/>
            </a:xfrm>
          </p:grpSpPr>
          <p:sp>
            <p:nvSpPr>
              <p:cNvPr id="50" name="Text Box 3"/>
              <p:cNvSpPr/>
              <p:nvPr/>
            </p:nvSpPr>
            <p:spPr>
              <a:xfrm>
                <a:off x="285840" y="2209680"/>
                <a:ext cx="481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 Box 4"/>
              <p:cNvSpPr/>
              <p:nvPr/>
            </p:nvSpPr>
            <p:spPr>
              <a:xfrm>
                <a:off x="338400" y="4229280"/>
                <a:ext cx="439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 Box 5"/>
              <p:cNvSpPr/>
              <p:nvPr/>
            </p:nvSpPr>
            <p:spPr>
              <a:xfrm>
                <a:off x="1634040" y="1076400"/>
                <a:ext cx="1210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Annexin IV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3" name="Picture 6" descr="Annexin A4 PE615b"/>
              <p:cNvPicPr/>
              <p:nvPr/>
            </p:nvPicPr>
            <p:blipFill>
              <a:blip r:embed="rId1"/>
              <a:stretch/>
            </p:blipFill>
            <p:spPr>
              <a:xfrm>
                <a:off x="844200" y="3429000"/>
                <a:ext cx="2772720" cy="1828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4" name="Picture 7" descr="Annexin A4 PE580b"/>
              <p:cNvPicPr/>
              <p:nvPr/>
            </p:nvPicPr>
            <p:blipFill>
              <a:blip r:embed="rId2"/>
              <a:stretch/>
            </p:blipFill>
            <p:spPr>
              <a:xfrm>
                <a:off x="844200" y="1447920"/>
                <a:ext cx="2772720" cy="1828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" name="Text Box 8"/>
              <p:cNvSpPr/>
              <p:nvPr/>
            </p:nvSpPr>
            <p:spPr>
              <a:xfrm>
                <a:off x="3464280" y="380880"/>
                <a:ext cx="6319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Suppl Figure S3-intended to be in colour in we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6" name="Picture 9" descr="Integrin B3  PE615 X20"/>
              <p:cNvPicPr/>
              <p:nvPr/>
            </p:nvPicPr>
            <p:blipFill>
              <a:blip r:embed="rId3"/>
              <a:stretch/>
            </p:blipFill>
            <p:spPr>
              <a:xfrm>
                <a:off x="3772800" y="3429000"/>
                <a:ext cx="2772360" cy="1828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7" name="Picture 10" descr="Integrin B3  PE580 X20"/>
              <p:cNvPicPr/>
              <p:nvPr/>
            </p:nvPicPr>
            <p:blipFill>
              <a:blip r:embed="rId4"/>
              <a:stretch/>
            </p:blipFill>
            <p:spPr>
              <a:xfrm>
                <a:off x="3772800" y="1447920"/>
                <a:ext cx="2772360" cy="1828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8" name="Text Box 11"/>
              <p:cNvSpPr/>
              <p:nvPr/>
            </p:nvSpPr>
            <p:spPr>
              <a:xfrm>
                <a:off x="4461120" y="1066680"/>
                <a:ext cx="1210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Integrin B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9" name="Picture 12" descr="Histone H4 PE615 X20"/>
              <p:cNvPicPr/>
              <p:nvPr/>
            </p:nvPicPr>
            <p:blipFill>
              <a:blip r:embed="rId5"/>
              <a:stretch/>
            </p:blipFill>
            <p:spPr>
              <a:xfrm>
                <a:off x="6643080" y="3400560"/>
                <a:ext cx="2772720" cy="1828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0" name="Picture 13" descr="Histone H4 PE580 X20"/>
              <p:cNvPicPr/>
              <p:nvPr/>
            </p:nvPicPr>
            <p:blipFill>
              <a:blip r:embed="rId6"/>
              <a:stretch/>
            </p:blipFill>
            <p:spPr>
              <a:xfrm>
                <a:off x="6659280" y="1433520"/>
                <a:ext cx="2772720" cy="1828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1" name="Text Box 14"/>
              <p:cNvSpPr/>
              <p:nvPr/>
            </p:nvSpPr>
            <p:spPr>
              <a:xfrm>
                <a:off x="7322400" y="1062000"/>
                <a:ext cx="1209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Histone H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2" name="Picture 15" descr="Negative Control_PE615_X20"/>
              <p:cNvPicPr/>
              <p:nvPr/>
            </p:nvPicPr>
            <p:blipFill>
              <a:blip r:embed="rId7"/>
              <a:stretch/>
            </p:blipFill>
            <p:spPr>
              <a:xfrm>
                <a:off x="9552600" y="3395520"/>
                <a:ext cx="2772360" cy="1828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" name="Picture 16" descr="Negative Control_PE580_X20"/>
              <p:cNvPicPr/>
              <p:nvPr/>
            </p:nvPicPr>
            <p:blipFill>
              <a:blip r:embed="rId8"/>
              <a:stretch/>
            </p:blipFill>
            <p:spPr>
              <a:xfrm>
                <a:off x="9571680" y="1447920"/>
                <a:ext cx="2772360" cy="1828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4" name="Text Box 17"/>
              <p:cNvSpPr/>
              <p:nvPr/>
            </p:nvSpPr>
            <p:spPr>
              <a:xfrm>
                <a:off x="9629280" y="1052640"/>
                <a:ext cx="2311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egative 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65" name="Straight Arrow Connector 21"/>
            <p:cNvCxnSpPr/>
            <p:nvPr/>
          </p:nvCxnSpPr>
          <p:spPr>
            <a:xfrm flipH="1" flipV="1">
              <a:off x="3199680" y="2818440"/>
              <a:ext cx="153000" cy="229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6" name="Straight Arrow Connector 23"/>
            <p:cNvCxnSpPr/>
            <p:nvPr/>
          </p:nvCxnSpPr>
          <p:spPr>
            <a:xfrm flipH="1" flipV="1">
              <a:off x="2133000" y="4190400"/>
              <a:ext cx="153000" cy="229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7" name="Straight Arrow Connector 27"/>
            <p:cNvCxnSpPr/>
            <p:nvPr/>
          </p:nvCxnSpPr>
          <p:spPr>
            <a:xfrm flipH="1" flipV="1">
              <a:off x="4952160" y="3961800"/>
              <a:ext cx="153000" cy="229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8" name="Straight Arrow Connector 44"/>
            <p:cNvCxnSpPr/>
            <p:nvPr/>
          </p:nvCxnSpPr>
          <p:spPr>
            <a:xfrm flipH="1" flipV="1">
              <a:off x="5637960" y="2132640"/>
              <a:ext cx="153000" cy="229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9" name="Straight Arrow Connector 45"/>
            <p:cNvCxnSpPr/>
            <p:nvPr/>
          </p:nvCxnSpPr>
          <p:spPr>
            <a:xfrm flipH="1" flipV="1">
              <a:off x="7848000" y="4190400"/>
              <a:ext cx="153000" cy="229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0" name="Straight Arrow Connector 46"/>
            <p:cNvCxnSpPr/>
            <p:nvPr/>
          </p:nvCxnSpPr>
          <p:spPr>
            <a:xfrm flipH="1" flipV="1">
              <a:off x="7390800" y="1904040"/>
              <a:ext cx="153000" cy="229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1T05:50:08Z</dcterms:created>
  <dc:creator>g0800062</dc:creator>
  <dc:description/>
  <dc:language>en-US</dc:language>
  <cp:lastModifiedBy>MDCSONI</cp:lastModifiedBy>
  <dcterms:modified xsi:type="dcterms:W3CDTF">2014-08-04T03:23:29Z</dcterms:modified>
  <cp:revision>11</cp:revision>
  <dc:subject/>
  <dc:title>Slide 1</dc:title>
</cp:coreProperties>
</file>